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68" d="100"/>
          <a:sy n="168" d="100"/>
        </p:scale>
        <p:origin x="-105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686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351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649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66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743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587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3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983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620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709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700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603C5-FB62-F74C-8812-1541D403072F}" type="datetimeFigureOut">
              <a:rPr lang="en-US" smtClean="0"/>
              <a:t>12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A7F365-BB6D-F14E-8433-49345E670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278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6755" y="131159"/>
            <a:ext cx="8255477" cy="658252"/>
          </a:xfrm>
        </p:spPr>
        <p:txBody>
          <a:bodyPr>
            <a:noAutofit/>
          </a:bodyPr>
          <a:lstStyle/>
          <a:p>
            <a:pPr algn="l"/>
            <a:r>
              <a:rPr lang="en-US" sz="2000" b="1" dirty="0" smtClean="0"/>
              <a:t>Fig. </a:t>
            </a:r>
            <a:r>
              <a:rPr lang="en-US" sz="2000" b="1" dirty="0" smtClean="0"/>
              <a:t>S1.  </a:t>
            </a:r>
            <a:r>
              <a:rPr lang="en-US" sz="2000" dirty="0" smtClean="0"/>
              <a:t>Open and shut joins with end modification may account for footprint-like sequences in VH6-1 rearrangements</a:t>
            </a:r>
            <a:endParaRPr lang="en-US" sz="2000" dirty="0"/>
          </a:p>
        </p:txBody>
      </p:sp>
      <p:sp>
        <p:nvSpPr>
          <p:cNvPr id="4" name="Rectangle 3"/>
          <p:cNvSpPr/>
          <p:nvPr/>
        </p:nvSpPr>
        <p:spPr>
          <a:xfrm>
            <a:off x="574919" y="1600677"/>
            <a:ext cx="5354469" cy="48051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5929388" y="1600677"/>
            <a:ext cx="652147" cy="48051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6581535" y="1600677"/>
            <a:ext cx="1930698" cy="480510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Triangle 6"/>
          <p:cNvSpPr/>
          <p:nvPr/>
        </p:nvSpPr>
        <p:spPr>
          <a:xfrm rot="2924382">
            <a:off x="4848197" y="1506290"/>
            <a:ext cx="643566" cy="574897"/>
          </a:xfrm>
          <a:prstGeom prst="rtTriangle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990108" y="925429"/>
            <a:ext cx="1510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CTGTG   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31746" y="1690368"/>
            <a:ext cx="1890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H6-1 </a:t>
            </a:r>
            <a:endParaRPr lang="en-US" dirty="0"/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4470638" y="2381505"/>
            <a:ext cx="8581" cy="56631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574920" y="3186217"/>
            <a:ext cx="4710902" cy="48051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6229718" y="3186217"/>
            <a:ext cx="652147" cy="48051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6881865" y="3186217"/>
            <a:ext cx="1930698" cy="480510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Triangle 17"/>
          <p:cNvSpPr/>
          <p:nvPr/>
        </p:nvSpPr>
        <p:spPr>
          <a:xfrm rot="2924382">
            <a:off x="4848197" y="3091830"/>
            <a:ext cx="643566" cy="574897"/>
          </a:xfrm>
          <a:prstGeom prst="rtTriangle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5500344" y="3186217"/>
            <a:ext cx="729374" cy="48051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Straight Connector 22"/>
          <p:cNvCxnSpPr/>
          <p:nvPr/>
        </p:nvCxnSpPr>
        <p:spPr>
          <a:xfrm flipH="1">
            <a:off x="5388792" y="3186217"/>
            <a:ext cx="111552" cy="20779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388792" y="3394009"/>
            <a:ext cx="209479" cy="14587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5388792" y="3539879"/>
            <a:ext cx="209479" cy="12684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5339806" y="920263"/>
            <a:ext cx="1209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A</a:t>
            </a:r>
            <a:r>
              <a:rPr lang="en-US" dirty="0" smtClean="0"/>
              <a:t>AGAGA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4136737" y="3756668"/>
            <a:ext cx="1209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CTGTGC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4741689" y="2450149"/>
            <a:ext cx="203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eavage</a:t>
            </a:r>
            <a:endParaRPr lang="en-US" dirty="0"/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4477163" y="4207111"/>
            <a:ext cx="8581" cy="56631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388792" y="3756668"/>
            <a:ext cx="1209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A</a:t>
            </a:r>
            <a:r>
              <a:rPr lang="en-US" dirty="0" smtClean="0"/>
              <a:t>AGAGA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4776012" y="4218336"/>
            <a:ext cx="203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ibble off the </a:t>
            </a:r>
            <a:r>
              <a:rPr lang="en-US" b="1" dirty="0" smtClean="0">
                <a:solidFill>
                  <a:srgbClr val="FF0000"/>
                </a:solidFill>
              </a:rPr>
              <a:t>A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574920" y="5011823"/>
            <a:ext cx="5268660" cy="48051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5843580" y="5011823"/>
            <a:ext cx="652147" cy="48051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6495727" y="5011823"/>
            <a:ext cx="1930698" cy="480510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ight Triangle 38"/>
          <p:cNvSpPr/>
          <p:nvPr/>
        </p:nvSpPr>
        <p:spPr>
          <a:xfrm rot="2924382">
            <a:off x="4848197" y="4917436"/>
            <a:ext cx="643566" cy="574897"/>
          </a:xfrm>
          <a:prstGeom prst="rtTriangle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4178888" y="5722148"/>
            <a:ext cx="2050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CTGTGCAGAGA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6023778" y="1698948"/>
            <a:ext cx="557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H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>
            <a:off x="6691030" y="1698948"/>
            <a:ext cx="557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731746" y="3209343"/>
            <a:ext cx="1890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H6-1 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731746" y="5029791"/>
            <a:ext cx="1890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H6-1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9050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39BA629A07A9F4BB6847AA682F917A8" ma:contentTypeVersion="7" ma:contentTypeDescription="Create a new document." ma:contentTypeScope="" ma:versionID="35c4100408f23215276ca7fbb6584ace">
  <xsd:schema xmlns:xsd="http://www.w3.org/2001/XMLSchema" xmlns:p="http://schemas.microsoft.com/office/2006/metadata/properties" xmlns:ns2="f9200e2c-35ea-4398-940a-5106842a3e9c" targetNamespace="http://schemas.microsoft.com/office/2006/metadata/properties" ma:root="true" ma:fieldsID="0d936c70b851f96e272aa3eebb5db539" ns2:_="">
    <xsd:import namespace="f9200e2c-35ea-4398-940a-5106842a3e9c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9200e2c-35ea-4398-940a-5106842a3e9c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f9200e2c-35ea-4398-940a-5106842a3e9c">
      <UserInfo>
        <DisplayName/>
        <AccountId xsi:nil="true"/>
        <AccountType/>
      </UserInfo>
    </Checked_x0020_Out_x0020_To>
    <IsDeleted xmlns="f9200e2c-35ea-4398-940a-5106842a3e9c">false</IsDeleted>
    <FileFormat xmlns="f9200e2c-35ea-4398-940a-5106842a3e9c">PPTX</FileFormat>
    <TitleName xmlns="f9200e2c-35ea-4398-940a-5106842a3e9c">Presentation 1.PPTX</TitleName>
    <StageName xmlns="f9200e2c-35ea-4398-940a-5106842a3e9c" xsi:nil="true"/>
    <DocumentId xmlns="f9200e2c-35ea-4398-940a-5106842a3e9c">Presentation 1.PPTX</DocumentId>
    <DocumentType xmlns="f9200e2c-35ea-4398-940a-5106842a3e9c">Presentation</DocumentType>
  </documentManagement>
</p:properties>
</file>

<file path=customXml/itemProps1.xml><?xml version="1.0" encoding="utf-8"?>
<ds:datastoreItem xmlns:ds="http://schemas.openxmlformats.org/officeDocument/2006/customXml" ds:itemID="{B3A84F8D-D07B-4DE5-8138-91EB448DE24A}"/>
</file>

<file path=customXml/itemProps2.xml><?xml version="1.0" encoding="utf-8"?>
<ds:datastoreItem xmlns:ds="http://schemas.openxmlformats.org/officeDocument/2006/customXml" ds:itemID="{A6E7F608-B822-4B61-9057-EB1AB078FECF}"/>
</file>

<file path=customXml/itemProps3.xml><?xml version="1.0" encoding="utf-8"?>
<ds:datastoreItem xmlns:ds="http://schemas.openxmlformats.org/officeDocument/2006/customXml" ds:itemID="{46506C3F-3A6A-48B8-9C9F-026F0B0E9A6D}"/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45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. S1.  Open and shut joins with end modification may account for footprint-like sequences in VH6-1 rearrangements</vt:lpstr>
    </vt:vector>
  </TitlesOfParts>
  <Company>University of Pennsylvan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S2</dc:title>
  <dc:creator>Eline Luning Prak</dc:creator>
  <cp:lastModifiedBy>Eline Luning Prak</cp:lastModifiedBy>
  <cp:revision>8</cp:revision>
  <dcterms:created xsi:type="dcterms:W3CDTF">2013-11-18T23:39:14Z</dcterms:created>
  <dcterms:modified xsi:type="dcterms:W3CDTF">2013-12-28T00:4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39BA629A07A9F4BB6847AA682F917A8</vt:lpwstr>
  </property>
</Properties>
</file>